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64" r:id="rId2"/>
    <p:sldId id="260" r:id="rId3"/>
    <p:sldId id="257" r:id="rId4"/>
    <p:sldId id="262" r:id="rId5"/>
    <p:sldId id="263" r:id="rId6"/>
    <p:sldId id="259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34868"/>
    <p:restoredTop sz="94654"/>
  </p:normalViewPr>
  <p:slideViewPr>
    <p:cSldViewPr snapToGrid="0">
      <p:cViewPr varScale="1">
        <p:scale>
          <a:sx n="57" d="100"/>
          <a:sy n="57" d="100"/>
        </p:scale>
        <p:origin x="34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CD941A-9B57-E040-B780-9DDE4BDF41E1}" type="datetimeFigureOut">
              <a:rPr lang="en-US" smtClean="0"/>
              <a:t>12/7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F0435B-ECC1-194C-B287-67D99A775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2639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F1E1C0-15A5-9581-5FC1-CE093DA6955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8E32CE6-BE74-2107-F947-7A4752B73F6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9624D7-685A-C9D6-C96C-FF90EAEA83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D26DA-13F0-6E43-A3A8-F5BD767FFA01}" type="datetimeFigureOut">
              <a:rPr lang="en-US" smtClean="0"/>
              <a:t>12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8B9EF2-AA00-A5CA-6D55-C845E8976D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7F7ACF-1412-EBFE-0308-E2F545C1FD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90AC4-D687-3D4E-83C9-4AFA90FA60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1549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55F3C8-E47C-04EA-B17C-D9CE8A9BA4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D0D7138-8697-9AF6-C61D-CFCFC1325B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C962AC-7991-7DAE-D3A0-07A1445C3A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D26DA-13F0-6E43-A3A8-F5BD767FFA01}" type="datetimeFigureOut">
              <a:rPr lang="en-US" smtClean="0"/>
              <a:t>12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6D4246-383A-CF82-E9AA-041AD4E2B3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7F8964-2C12-8646-5BEB-CD1EAD1C09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90AC4-D687-3D4E-83C9-4AFA90FA60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06702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12E7E0A-334E-7020-EFA3-3ABA8E0A035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9245D74-354B-BF14-6C5A-4D56990474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3901FB-5A86-2460-9F8B-E25EBB908C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D26DA-13F0-6E43-A3A8-F5BD767FFA01}" type="datetimeFigureOut">
              <a:rPr lang="en-US" smtClean="0"/>
              <a:t>12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C2856E-2894-0B1A-B1EB-6A24E0B831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E225A2-7989-3EC6-0145-9F8F0CE569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90AC4-D687-3D4E-83C9-4AFA90FA60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92343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1555BD-2B57-551D-44BD-215E44526A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DDF9F1-6246-D3F0-4392-97710998570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20B820-E6DD-B322-0238-7C3D1D9EBC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D26DA-13F0-6E43-A3A8-F5BD767FFA01}" type="datetimeFigureOut">
              <a:rPr lang="en-US" smtClean="0"/>
              <a:t>12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70BFE0-0076-4E7A-C2FD-DD751C049A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B80AE8-59EE-DDE1-6FB3-59706D7511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90AC4-D687-3D4E-83C9-4AFA90FA60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71842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1CD38E-6968-A9F3-2637-1C30381E80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2F3A35-1CCA-1A3B-8E73-5A1B04FFA0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FF0C9D-4994-FBCA-0EA7-D3F76AB95A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D26DA-13F0-6E43-A3A8-F5BD767FFA01}" type="datetimeFigureOut">
              <a:rPr lang="en-US" smtClean="0"/>
              <a:t>12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1A8D25-7FC7-E306-6910-8201BCBF0C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BA7A31-1F45-F4A6-8BAE-D32FD66274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90AC4-D687-3D4E-83C9-4AFA90FA60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62984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664FD4-A1E6-0B52-76B9-8B17C12396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0F3830A-F680-318A-4257-89CEFB08420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88A2350-215A-7E77-2DD8-260DA6A1AD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69FBA2-4C9D-BC9A-7ECA-0B085B6C77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D26DA-13F0-6E43-A3A8-F5BD767FFA01}" type="datetimeFigureOut">
              <a:rPr lang="en-US" smtClean="0"/>
              <a:t>12/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50BF81E-1996-A0AC-6932-5121C08D97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6FA0931-E74C-66D8-2402-3A6D60853B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90AC4-D687-3D4E-83C9-4AFA90FA60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17202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A91F7E-FFF5-7DAE-6F7B-EC11F05BC5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A067DAA-59C8-09B4-7931-1F061611B2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0BE805-6DA4-9A85-3509-888874989E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121A751-296B-B3F0-4C79-E6F2B60075C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DA80BFA-D010-24C8-D333-CC6766264E3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0D1FCED-C091-7CD4-1A3F-8B57020FE4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D26DA-13F0-6E43-A3A8-F5BD767FFA01}" type="datetimeFigureOut">
              <a:rPr lang="en-US" smtClean="0"/>
              <a:t>12/7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2C7F9E2-F469-0AED-967F-8C23A59128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D297EAE-411F-CE0B-6F79-B4F1945491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90AC4-D687-3D4E-83C9-4AFA90FA60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60121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C7A8BB-9F46-31EF-003F-D134B6A7E5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DA29DD8-6210-833A-ADE8-42BCA23E22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D26DA-13F0-6E43-A3A8-F5BD767FFA01}" type="datetimeFigureOut">
              <a:rPr lang="en-US" smtClean="0"/>
              <a:t>12/7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DDD27E5-F5E2-A329-026D-941423216C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03C3A6D-D585-BBB6-3D29-9C88AD36A3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90AC4-D687-3D4E-83C9-4AFA90FA60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502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6F82A2B-754E-02B3-9883-18DF49F9D1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D26DA-13F0-6E43-A3A8-F5BD767FFA01}" type="datetimeFigureOut">
              <a:rPr lang="en-US" smtClean="0"/>
              <a:t>12/7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780721E-71C8-B868-7AAC-BA9C66DCFC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B152EB7-CB5D-2164-8ADC-EA71853E7B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90AC4-D687-3D4E-83C9-4AFA90FA60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15488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F50CE6-D365-A5A9-776B-64CC7B3BF4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677431A-8CA7-494E-8704-3CC223028CC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4D09136-7870-81E5-7F21-E5C17AE663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9B9EB9C-8538-40CC-E095-0864AFB16D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D26DA-13F0-6E43-A3A8-F5BD767FFA01}" type="datetimeFigureOut">
              <a:rPr lang="en-US" smtClean="0"/>
              <a:t>12/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1A5EBAA-3CE2-F68B-A265-278ECFC01B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D6DFCC-4F27-3C4A-87A0-A1B1BC7286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90AC4-D687-3D4E-83C9-4AFA90FA60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56973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AB6808-543B-100A-5F46-439C2E6794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FD66EFC-7E7B-19EC-7E52-DE444222DEF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A963C2C-711C-04D3-5193-0E140E53EE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F5CA6A-4038-06F5-C5C8-623B918664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D26DA-13F0-6E43-A3A8-F5BD767FFA01}" type="datetimeFigureOut">
              <a:rPr lang="en-US" smtClean="0"/>
              <a:t>12/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B2A7631-6E5B-9F24-F4AB-D8F816B084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47C7204-216C-2098-1049-3F60A176C8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90AC4-D687-3D4E-83C9-4AFA90FA60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4909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DC44A00-661F-A58B-BED8-2A884D70E0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934139-649D-04BE-82F9-18A368BFA6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415967-28AA-DDEE-987D-E7ED9AD05DD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0D26DA-13F0-6E43-A3A8-F5BD767FFA01}" type="datetimeFigureOut">
              <a:rPr lang="en-US" smtClean="0"/>
              <a:t>12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77BE0E-565D-49DC-5E5A-8D65D799608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029ED6-3669-F99C-1C5E-CBB4854F974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890AC4-D687-3D4E-83C9-4AFA90FA60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8924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179646AB-342E-B5EE-DECD-1FBECF0DADD7}"/>
              </a:ext>
            </a:extLst>
          </p:cNvPr>
          <p:cNvSpPr txBox="1"/>
          <p:nvPr/>
        </p:nvSpPr>
        <p:spPr>
          <a:xfrm>
            <a:off x="1510146" y="6402990"/>
            <a:ext cx="113468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Supplementary Table S1. 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Multivariable logistic regression predicting treatment allocation.</a:t>
            </a:r>
            <a:r>
              <a:rPr lang="en-AU" dirty="0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7" name="Picture 6" descr="A table with numbers and text&#10;&#10;Description automatically generated">
            <a:extLst>
              <a:ext uri="{FF2B5EF4-FFF2-40B4-BE49-F238E27FC236}">
                <a16:creationId xmlns:a16="http://schemas.microsoft.com/office/drawing/2014/main" id="{D1E2FE68-2E76-B867-FBC0-6A0EA4AC3F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33989" y="0"/>
            <a:ext cx="7772400" cy="64035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99855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D7309348-5936-ADA4-E7ED-505CFDF231E1}"/>
              </a:ext>
            </a:extLst>
          </p:cNvPr>
          <p:cNvSpPr txBox="1"/>
          <p:nvPr/>
        </p:nvSpPr>
        <p:spPr>
          <a:xfrm>
            <a:off x="3220055" y="6490290"/>
            <a:ext cx="113468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1.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ecurrence-free survival in original cohort.</a:t>
            </a:r>
            <a:r>
              <a:rPr lang="en-AU" dirty="0">
                <a:effectLst/>
              </a:rPr>
              <a:t> </a:t>
            </a:r>
            <a:endParaRPr lang="en-US" dirty="0"/>
          </a:p>
        </p:txBody>
      </p:sp>
      <p:pic>
        <p:nvPicPr>
          <p:cNvPr id="3" name="Picture 2" descr="A graph of a graph showing the number of cohorts&#10;&#10;Description automatically generated">
            <a:extLst>
              <a:ext uri="{FF2B5EF4-FFF2-40B4-BE49-F238E27FC236}">
                <a16:creationId xmlns:a16="http://schemas.microsoft.com/office/drawing/2014/main" id="{91D04C7C-F66E-FD05-DE9A-4502BE99291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5400" y="0"/>
            <a:ext cx="10017641" cy="594354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C643A3D-CD8B-D0C2-03CC-73712177CADB}"/>
              </a:ext>
            </a:extLst>
          </p:cNvPr>
          <p:cNvSpPr txBox="1"/>
          <p:nvPr/>
        </p:nvSpPr>
        <p:spPr>
          <a:xfrm>
            <a:off x="7688145" y="1743255"/>
            <a:ext cx="1205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PT Serif" panose="020A0603040505020204" pitchFamily="18" charset="77"/>
              </a:rPr>
              <a:t>p&lt;0.00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65A1837-3155-08F1-F1EF-2984D611D544}"/>
              </a:ext>
            </a:extLst>
          </p:cNvPr>
          <p:cNvSpPr txBox="1"/>
          <p:nvPr/>
        </p:nvSpPr>
        <p:spPr>
          <a:xfrm>
            <a:off x="507202" y="5566960"/>
            <a:ext cx="958430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Palatino Linotype" panose="02040502050505030304" pitchFamily="18" charset="0"/>
              </a:rPr>
              <a:t>No. at risk</a:t>
            </a:r>
          </a:p>
          <a:p>
            <a:r>
              <a:rPr lang="en-US" dirty="0">
                <a:latin typeface="Palatino Linotype" panose="02040502050505030304" pitchFamily="18" charset="0"/>
              </a:rPr>
              <a:t>Ablation              222                             119                         46                              5</a:t>
            </a:r>
          </a:p>
          <a:p>
            <a:r>
              <a:rPr lang="en-US" dirty="0">
                <a:latin typeface="Palatino Linotype" panose="02040502050505030304" pitchFamily="18" charset="0"/>
              </a:rPr>
              <a:t>Resection            196                             153                         82                              25</a:t>
            </a:r>
          </a:p>
        </p:txBody>
      </p:sp>
    </p:spTree>
    <p:extLst>
      <p:ext uri="{BB962C8B-B14F-4D97-AF65-F5344CB8AC3E}">
        <p14:creationId xmlns:p14="http://schemas.microsoft.com/office/powerpoint/2010/main" val="18750332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3A137AE3-2502-6F72-AC98-4BF4CDA8ED91}"/>
              </a:ext>
            </a:extLst>
          </p:cNvPr>
          <p:cNvSpPr txBox="1"/>
          <p:nvPr/>
        </p:nvSpPr>
        <p:spPr>
          <a:xfrm>
            <a:off x="1136073" y="6429502"/>
            <a:ext cx="113468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2.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Local recurrence-free survival in matched cohort with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umours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&gt;3cm excluded</a:t>
            </a:r>
            <a:r>
              <a:rPr lang="en-AU" sz="18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</a:t>
            </a:r>
            <a:endParaRPr lang="en-US" dirty="0"/>
          </a:p>
        </p:txBody>
      </p:sp>
      <p:pic>
        <p:nvPicPr>
          <p:cNvPr id="6" name="Picture 5" descr="A graph with blue and red lines&#10;&#10;Description automatically generated">
            <a:extLst>
              <a:ext uri="{FF2B5EF4-FFF2-40B4-BE49-F238E27FC236}">
                <a16:creationId xmlns:a16="http://schemas.microsoft.com/office/drawing/2014/main" id="{35C516B1-B42C-0979-EA73-8B1292AB5A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6920" y="243832"/>
            <a:ext cx="10097387" cy="551901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512EEC9-D0FA-EF3E-0185-9C1730FB1322}"/>
              </a:ext>
            </a:extLst>
          </p:cNvPr>
          <p:cNvSpPr txBox="1"/>
          <p:nvPr/>
        </p:nvSpPr>
        <p:spPr>
          <a:xfrm>
            <a:off x="507202" y="5566960"/>
            <a:ext cx="958430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Palatino Linotype" panose="02040502050505030304" pitchFamily="18" charset="0"/>
              </a:rPr>
              <a:t>No. at risk</a:t>
            </a:r>
          </a:p>
          <a:p>
            <a:r>
              <a:rPr lang="en-US" dirty="0">
                <a:latin typeface="Palatino Linotype" panose="02040502050505030304" pitchFamily="18" charset="0"/>
              </a:rPr>
              <a:t>Ablation              65                              48                             23                             6</a:t>
            </a:r>
          </a:p>
          <a:p>
            <a:r>
              <a:rPr lang="en-US" dirty="0">
                <a:latin typeface="Palatino Linotype" panose="02040502050505030304" pitchFamily="18" charset="0"/>
              </a:rPr>
              <a:t>Resection            64                               60                             34                             7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4129C6D-991A-8516-6302-DF1744DBCA7E}"/>
              </a:ext>
            </a:extLst>
          </p:cNvPr>
          <p:cNvSpPr txBox="1"/>
          <p:nvPr/>
        </p:nvSpPr>
        <p:spPr>
          <a:xfrm>
            <a:off x="7787704" y="1998437"/>
            <a:ext cx="1205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PT Serif" panose="020A0603040505020204" pitchFamily="18" charset="77"/>
              </a:rPr>
              <a:t>p=0.028</a:t>
            </a:r>
          </a:p>
        </p:txBody>
      </p:sp>
    </p:spTree>
    <p:extLst>
      <p:ext uri="{BB962C8B-B14F-4D97-AF65-F5344CB8AC3E}">
        <p14:creationId xmlns:p14="http://schemas.microsoft.com/office/powerpoint/2010/main" val="22450514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50242556-B800-2F7C-DC0A-644E453B2916}"/>
              </a:ext>
            </a:extLst>
          </p:cNvPr>
          <p:cNvSpPr txBox="1"/>
          <p:nvPr/>
        </p:nvSpPr>
        <p:spPr>
          <a:xfrm>
            <a:off x="2114268" y="6488668"/>
            <a:ext cx="113468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3.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Local recurrence-free survival in original cohort</a:t>
            </a:r>
            <a:r>
              <a:rPr lang="en-AU" sz="18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</a:t>
            </a:r>
            <a:endParaRPr lang="en-US" dirty="0"/>
          </a:p>
        </p:txBody>
      </p:sp>
      <p:pic>
        <p:nvPicPr>
          <p:cNvPr id="6" name="Picture 5" descr="A graph of a number of patients&#10;&#10;Description automatically generated">
            <a:extLst>
              <a:ext uri="{FF2B5EF4-FFF2-40B4-BE49-F238E27FC236}">
                <a16:creationId xmlns:a16="http://schemas.microsoft.com/office/drawing/2014/main" id="{A9ABC63F-9FB1-BD6C-2DF1-4A89A7D1A79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86704" y="0"/>
            <a:ext cx="10298093" cy="5890437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398EC98-A69D-9DF6-D5AD-3BE8ECBAAC4F}"/>
              </a:ext>
            </a:extLst>
          </p:cNvPr>
          <p:cNvSpPr txBox="1"/>
          <p:nvPr/>
        </p:nvSpPr>
        <p:spPr>
          <a:xfrm>
            <a:off x="507202" y="5566960"/>
            <a:ext cx="958430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Palatino Linotype" panose="02040502050505030304" pitchFamily="18" charset="0"/>
              </a:rPr>
              <a:t>No. at risk</a:t>
            </a:r>
          </a:p>
          <a:p>
            <a:r>
              <a:rPr lang="en-US" dirty="0">
                <a:latin typeface="Palatino Linotype" panose="02040502050505030304" pitchFamily="18" charset="0"/>
              </a:rPr>
              <a:t>Ablation              222                             158                             71                              12</a:t>
            </a:r>
          </a:p>
          <a:p>
            <a:r>
              <a:rPr lang="en-US" dirty="0">
                <a:latin typeface="Palatino Linotype" panose="02040502050505030304" pitchFamily="18" charset="0"/>
              </a:rPr>
              <a:t>Resection            196                             182                             116                             3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11197B1-0692-EC5A-DE87-15E264A0E7F8}"/>
              </a:ext>
            </a:extLst>
          </p:cNvPr>
          <p:cNvSpPr txBox="1"/>
          <p:nvPr/>
        </p:nvSpPr>
        <p:spPr>
          <a:xfrm>
            <a:off x="7787704" y="1998437"/>
            <a:ext cx="1205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PT Serif" panose="020A0603040505020204" pitchFamily="18" charset="77"/>
              </a:rPr>
              <a:t>p&lt;0.001</a:t>
            </a:r>
          </a:p>
        </p:txBody>
      </p:sp>
    </p:spTree>
    <p:extLst>
      <p:ext uri="{BB962C8B-B14F-4D97-AF65-F5344CB8AC3E}">
        <p14:creationId xmlns:p14="http://schemas.microsoft.com/office/powerpoint/2010/main" val="10709326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65DF406-0D15-46FC-D92F-D269F42DA95A}"/>
              </a:ext>
            </a:extLst>
          </p:cNvPr>
          <p:cNvSpPr txBox="1"/>
          <p:nvPr/>
        </p:nvSpPr>
        <p:spPr>
          <a:xfrm>
            <a:off x="1136073" y="6521281"/>
            <a:ext cx="113468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4.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verall survival in matched cohort with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umours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&gt;3cm excluded.</a:t>
            </a:r>
            <a:endParaRPr lang="en-US" dirty="0"/>
          </a:p>
        </p:txBody>
      </p:sp>
      <p:pic>
        <p:nvPicPr>
          <p:cNvPr id="8" name="Picture 7" descr="A graph with lines and numbers&#10;&#10;Description automatically generated with medium confidence">
            <a:extLst>
              <a:ext uri="{FF2B5EF4-FFF2-40B4-BE49-F238E27FC236}">
                <a16:creationId xmlns:a16="http://schemas.microsoft.com/office/drawing/2014/main" id="{8FB41DEA-D9CE-64F6-4A7B-F176FFC8FDF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05737" y="367710"/>
            <a:ext cx="10645259" cy="5471194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14FCF7C2-8765-2C5D-7892-A490A364B751}"/>
              </a:ext>
            </a:extLst>
          </p:cNvPr>
          <p:cNvSpPr txBox="1"/>
          <p:nvPr/>
        </p:nvSpPr>
        <p:spPr>
          <a:xfrm>
            <a:off x="7787704" y="1998437"/>
            <a:ext cx="1205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PT Serif" panose="020A0603040505020204" pitchFamily="18" charset="77"/>
              </a:rPr>
              <a:t>p=0.10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2A63663-F765-A523-E896-05CBFEA31940}"/>
              </a:ext>
            </a:extLst>
          </p:cNvPr>
          <p:cNvSpPr txBox="1"/>
          <p:nvPr/>
        </p:nvSpPr>
        <p:spPr>
          <a:xfrm>
            <a:off x="507202" y="5566960"/>
            <a:ext cx="958430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Palatino Linotype" panose="02040502050505030304" pitchFamily="18" charset="0"/>
              </a:rPr>
              <a:t>No. at risk</a:t>
            </a:r>
          </a:p>
          <a:p>
            <a:r>
              <a:rPr lang="en-US" dirty="0">
                <a:latin typeface="Palatino Linotype" panose="02040502050505030304" pitchFamily="18" charset="0"/>
              </a:rPr>
              <a:t>Ablation              68                              65                             40                             10</a:t>
            </a:r>
          </a:p>
          <a:p>
            <a:r>
              <a:rPr lang="en-US" dirty="0">
                <a:latin typeface="Palatino Linotype" panose="02040502050505030304" pitchFamily="18" charset="0"/>
              </a:rPr>
              <a:t>Resection            64                              63                              39                             7</a:t>
            </a:r>
          </a:p>
        </p:txBody>
      </p:sp>
    </p:spTree>
    <p:extLst>
      <p:ext uri="{BB962C8B-B14F-4D97-AF65-F5344CB8AC3E}">
        <p14:creationId xmlns:p14="http://schemas.microsoft.com/office/powerpoint/2010/main" val="291497863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2784569-C198-6454-F565-1012573FBDC1}"/>
              </a:ext>
            </a:extLst>
          </p:cNvPr>
          <p:cNvSpPr txBox="1"/>
          <p:nvPr/>
        </p:nvSpPr>
        <p:spPr>
          <a:xfrm>
            <a:off x="3484902" y="6488668"/>
            <a:ext cx="113468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5.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verall survival in original cohort.</a:t>
            </a:r>
            <a:r>
              <a:rPr lang="en-AU" dirty="0">
                <a:effectLst/>
              </a:rPr>
              <a:t> </a:t>
            </a:r>
            <a:r>
              <a:rPr lang="en-US" dirty="0"/>
              <a:t>.</a:t>
            </a:r>
          </a:p>
        </p:txBody>
      </p:sp>
      <p:pic>
        <p:nvPicPr>
          <p:cNvPr id="6" name="Picture 5" descr="A graph of a cohort&#10;&#10;Description automatically generated">
            <a:extLst>
              <a:ext uri="{FF2B5EF4-FFF2-40B4-BE49-F238E27FC236}">
                <a16:creationId xmlns:a16="http://schemas.microsoft.com/office/drawing/2014/main" id="{E6764C58-8241-FA4A-CA9C-1243F44F333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06450" y="1"/>
            <a:ext cx="10278348" cy="5805376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9437DF7-E698-BEB3-A0C2-AA98FB0D5428}"/>
              </a:ext>
            </a:extLst>
          </p:cNvPr>
          <p:cNvSpPr txBox="1"/>
          <p:nvPr/>
        </p:nvSpPr>
        <p:spPr>
          <a:xfrm>
            <a:off x="507202" y="5566960"/>
            <a:ext cx="958430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Palatino Linotype" panose="02040502050505030304" pitchFamily="18" charset="0"/>
              </a:rPr>
              <a:t>No. at risk</a:t>
            </a:r>
          </a:p>
          <a:p>
            <a:r>
              <a:rPr lang="en-US" dirty="0">
                <a:latin typeface="Palatino Linotype" panose="02040502050505030304" pitchFamily="18" charset="0"/>
              </a:rPr>
              <a:t>Ablation              254                             227                            121                            26</a:t>
            </a:r>
          </a:p>
          <a:p>
            <a:r>
              <a:rPr lang="en-US" dirty="0">
                <a:latin typeface="Palatino Linotype" panose="02040502050505030304" pitchFamily="18" charset="0"/>
              </a:rPr>
              <a:t>Resection            196                             191                             126                            3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3F8C276-6B67-CBA2-A98E-C04130C18C93}"/>
              </a:ext>
            </a:extLst>
          </p:cNvPr>
          <p:cNvSpPr txBox="1"/>
          <p:nvPr/>
        </p:nvSpPr>
        <p:spPr>
          <a:xfrm>
            <a:off x="7952992" y="1636929"/>
            <a:ext cx="1205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PT Serif" panose="020A0603040505020204" pitchFamily="18" charset="77"/>
              </a:rPr>
              <a:t>p&lt;0.001</a:t>
            </a:r>
          </a:p>
        </p:txBody>
      </p:sp>
    </p:spTree>
    <p:extLst>
      <p:ext uri="{BB962C8B-B14F-4D97-AF65-F5344CB8AC3E}">
        <p14:creationId xmlns:p14="http://schemas.microsoft.com/office/powerpoint/2010/main" val="8343846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83</TotalTime>
  <Words>154</Words>
  <Application>Microsoft Office PowerPoint</Application>
  <PresentationFormat>Widescreen</PresentationFormat>
  <Paragraphs>2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Palatino Linotype</vt:lpstr>
      <vt:lpstr>PT Serif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nathan Abdelmalak</dc:creator>
  <cp:lastModifiedBy>MDPI</cp:lastModifiedBy>
  <cp:revision>33</cp:revision>
  <dcterms:created xsi:type="dcterms:W3CDTF">2023-10-22T04:45:13Z</dcterms:created>
  <dcterms:modified xsi:type="dcterms:W3CDTF">2023-12-07T09:50:49Z</dcterms:modified>
</cp:coreProperties>
</file>